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77A37-9A74-4E30-8DB6-3782500E8F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EF4864-A07D-454A-9EE4-B3F631ED24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12DDB6-86A0-474F-AECF-142DD7D94B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C03679-111F-4211-BD6A-1182B18D51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4A6A2F-3722-427E-A186-C3027CA0BB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789779-0432-4F52-BDB6-F760759FA7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CDF01B-D183-4229-B147-CC690EB09E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13F2E6-C71D-4C33-BFE2-5455070930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D3BD5-AB01-46EF-8839-142336647E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955672-2A17-4D93-B957-BDFFD6559F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BD5C08-57F6-4FEC-AEFD-C6470E4D30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11E5C1-FE68-43E0-9684-2A5E2BA3EA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99794DB-C54B-4BAE-BE5B-1D4FF4F8E7D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ruta 26"/>
          <p:cNvSpPr/>
          <p:nvPr/>
        </p:nvSpPr>
        <p:spPr>
          <a:xfrm>
            <a:off x="234360" y="3859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ruta 27"/>
          <p:cNvSpPr/>
          <p:nvPr/>
        </p:nvSpPr>
        <p:spPr>
          <a:xfrm>
            <a:off x="4587120" y="3859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28" descr=""/>
          <p:cNvPicPr/>
          <p:nvPr/>
        </p:nvPicPr>
        <p:blipFill>
          <a:blip r:embed="rId1"/>
          <a:stretch/>
        </p:blipFill>
        <p:spPr>
          <a:xfrm>
            <a:off x="4584600" y="693720"/>
            <a:ext cx="4508640" cy="33526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29" descr=""/>
          <p:cNvPicPr/>
          <p:nvPr/>
        </p:nvPicPr>
        <p:blipFill>
          <a:blip r:embed="rId2"/>
          <a:srcRect l="0" t="0" r="0" b="38164"/>
          <a:stretch/>
        </p:blipFill>
        <p:spPr>
          <a:xfrm>
            <a:off x="231840" y="693720"/>
            <a:ext cx="4216320" cy="3389400"/>
          </a:xfrm>
          <a:prstGeom prst="rect">
            <a:avLst/>
          </a:prstGeom>
          <a:ln w="0">
            <a:noFill/>
          </a:ln>
        </p:spPr>
      </p:pic>
      <p:sp>
        <p:nvSpPr>
          <p:cNvPr id="45" name="textruta 31"/>
          <p:cNvSpPr/>
          <p:nvPr/>
        </p:nvSpPr>
        <p:spPr>
          <a:xfrm>
            <a:off x="482760" y="923760"/>
            <a:ext cx="48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A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ruta 32"/>
          <p:cNvSpPr/>
          <p:nvPr/>
        </p:nvSpPr>
        <p:spPr>
          <a:xfrm>
            <a:off x="4942800" y="914400"/>
            <a:ext cx="717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atchwork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ktangel 34"/>
          <p:cNvSpPr/>
          <p:nvPr/>
        </p:nvSpPr>
        <p:spPr>
          <a:xfrm>
            <a:off x="4584600" y="1146240"/>
            <a:ext cx="200160" cy="1290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ruta 33"/>
          <p:cNvSpPr/>
          <p:nvPr/>
        </p:nvSpPr>
        <p:spPr>
          <a:xfrm rot="16200000">
            <a:off x="4036680" y="1680120"/>
            <a:ext cx="1294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llelic imbalance ratio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ruta 35"/>
          <p:cNvSpPr/>
          <p:nvPr/>
        </p:nvSpPr>
        <p:spPr>
          <a:xfrm rot="16200000">
            <a:off x="4142520" y="3201120"/>
            <a:ext cx="97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otal and mino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py numbe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ruta 36"/>
          <p:cNvSpPr/>
          <p:nvPr/>
        </p:nvSpPr>
        <p:spPr>
          <a:xfrm rot="16200000">
            <a:off x="-335520" y="3172320"/>
            <a:ext cx="97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otal and mino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py numbe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ktangel 37"/>
          <p:cNvSpPr/>
          <p:nvPr/>
        </p:nvSpPr>
        <p:spPr>
          <a:xfrm>
            <a:off x="6429240" y="2757600"/>
            <a:ext cx="1143000" cy="11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ktangel 38"/>
          <p:cNvSpPr/>
          <p:nvPr/>
        </p:nvSpPr>
        <p:spPr>
          <a:xfrm>
            <a:off x="6143760" y="3849840"/>
            <a:ext cx="1638000" cy="117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ktangel 39"/>
          <p:cNvSpPr/>
          <p:nvPr/>
        </p:nvSpPr>
        <p:spPr>
          <a:xfrm>
            <a:off x="1447920" y="3881520"/>
            <a:ext cx="1638360" cy="11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ktangel 40"/>
          <p:cNvSpPr/>
          <p:nvPr/>
        </p:nvSpPr>
        <p:spPr>
          <a:xfrm>
            <a:off x="1447920" y="2776680"/>
            <a:ext cx="1638360" cy="11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ruta 41"/>
          <p:cNvSpPr/>
          <p:nvPr/>
        </p:nvSpPr>
        <p:spPr>
          <a:xfrm>
            <a:off x="6432840" y="2738520"/>
            <a:ext cx="1267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ormalized coverag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ruta 42"/>
          <p:cNvSpPr/>
          <p:nvPr/>
        </p:nvSpPr>
        <p:spPr>
          <a:xfrm>
            <a:off x="1882080" y="2738520"/>
            <a:ext cx="48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og 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ruta 43"/>
          <p:cNvSpPr/>
          <p:nvPr/>
        </p:nvSpPr>
        <p:spPr>
          <a:xfrm>
            <a:off x="6148440" y="3833640"/>
            <a:ext cx="1707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hromosomal location, chr 1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ruta 44"/>
          <p:cNvSpPr/>
          <p:nvPr/>
        </p:nvSpPr>
        <p:spPr>
          <a:xfrm>
            <a:off x="1517760" y="3859200"/>
            <a:ext cx="1707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hromosomal location, chr 1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ktangel 45"/>
          <p:cNvSpPr/>
          <p:nvPr/>
        </p:nvSpPr>
        <p:spPr>
          <a:xfrm rot="16200000">
            <a:off x="-587880" y="1768680"/>
            <a:ext cx="1638360" cy="11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ruta 46"/>
          <p:cNvSpPr/>
          <p:nvPr/>
        </p:nvSpPr>
        <p:spPr>
          <a:xfrm rot="16200000">
            <a:off x="-341640" y="1543320"/>
            <a:ext cx="1070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llelic imbalance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ruta 21"/>
          <p:cNvSpPr/>
          <p:nvPr/>
        </p:nvSpPr>
        <p:spPr>
          <a:xfrm>
            <a:off x="518400" y="4552920"/>
            <a:ext cx="860076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data 1. Visualizations of TAPS and Patchwork results for cell lin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CC1954. Panels A-F illustrate genomic differences affecting whole chromosome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r chromsome arms for chr. 13, 15 and 5. These differences presumably ocurre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uring culture.These chromosomes were excluded for performance evalua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4" descr=""/>
          <p:cNvPicPr/>
          <p:nvPr/>
        </p:nvPicPr>
        <p:blipFill>
          <a:blip r:embed="rId1"/>
          <a:stretch/>
        </p:blipFill>
        <p:spPr>
          <a:xfrm>
            <a:off x="4606920" y="401760"/>
            <a:ext cx="4492800" cy="37386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3" descr=""/>
          <p:cNvPicPr/>
          <p:nvPr/>
        </p:nvPicPr>
        <p:blipFill>
          <a:blip r:embed="rId2"/>
          <a:stretch/>
        </p:blipFill>
        <p:spPr>
          <a:xfrm>
            <a:off x="225360" y="376200"/>
            <a:ext cx="4343400" cy="3719520"/>
          </a:xfrm>
          <a:prstGeom prst="rect">
            <a:avLst/>
          </a:prstGeom>
          <a:ln w="0">
            <a:noFill/>
          </a:ln>
        </p:spPr>
      </p:pic>
      <p:sp>
        <p:nvSpPr>
          <p:cNvPr id="64" name="textruta 26"/>
          <p:cNvSpPr/>
          <p:nvPr/>
        </p:nvSpPr>
        <p:spPr>
          <a:xfrm>
            <a:off x="234360" y="3859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ruta 27"/>
          <p:cNvSpPr/>
          <p:nvPr/>
        </p:nvSpPr>
        <p:spPr>
          <a:xfrm>
            <a:off x="4587120" y="3859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ruta 31"/>
          <p:cNvSpPr/>
          <p:nvPr/>
        </p:nvSpPr>
        <p:spPr>
          <a:xfrm>
            <a:off x="482760" y="923760"/>
            <a:ext cx="48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A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ruta 32"/>
          <p:cNvSpPr/>
          <p:nvPr/>
        </p:nvSpPr>
        <p:spPr>
          <a:xfrm>
            <a:off x="4942800" y="914400"/>
            <a:ext cx="717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atchwork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ktangel 34"/>
          <p:cNvSpPr/>
          <p:nvPr/>
        </p:nvSpPr>
        <p:spPr>
          <a:xfrm>
            <a:off x="4584600" y="1146240"/>
            <a:ext cx="200160" cy="1290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ruta 33"/>
          <p:cNvSpPr/>
          <p:nvPr/>
        </p:nvSpPr>
        <p:spPr>
          <a:xfrm rot="16200000">
            <a:off x="4036680" y="1680120"/>
            <a:ext cx="1294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llelic imbalance ratio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ruta 35"/>
          <p:cNvSpPr/>
          <p:nvPr/>
        </p:nvSpPr>
        <p:spPr>
          <a:xfrm rot="16200000">
            <a:off x="4142520" y="3201120"/>
            <a:ext cx="97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otal and mino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py numbe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ruta 36"/>
          <p:cNvSpPr/>
          <p:nvPr/>
        </p:nvSpPr>
        <p:spPr>
          <a:xfrm rot="16200000">
            <a:off x="-335520" y="3172320"/>
            <a:ext cx="97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otal and mino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py numbe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ktangel 37"/>
          <p:cNvSpPr/>
          <p:nvPr/>
        </p:nvSpPr>
        <p:spPr>
          <a:xfrm>
            <a:off x="6429240" y="2757600"/>
            <a:ext cx="1143000" cy="11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ktangel 38"/>
          <p:cNvSpPr/>
          <p:nvPr/>
        </p:nvSpPr>
        <p:spPr>
          <a:xfrm>
            <a:off x="6143760" y="3849840"/>
            <a:ext cx="1638000" cy="117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ktangel 39"/>
          <p:cNvSpPr/>
          <p:nvPr/>
        </p:nvSpPr>
        <p:spPr>
          <a:xfrm>
            <a:off x="1447920" y="3881520"/>
            <a:ext cx="1638360" cy="11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ktangel 40"/>
          <p:cNvSpPr/>
          <p:nvPr/>
        </p:nvSpPr>
        <p:spPr>
          <a:xfrm>
            <a:off x="1447920" y="2776680"/>
            <a:ext cx="1638360" cy="11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ruta 41"/>
          <p:cNvSpPr/>
          <p:nvPr/>
        </p:nvSpPr>
        <p:spPr>
          <a:xfrm>
            <a:off x="6432840" y="2738520"/>
            <a:ext cx="1267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ormalized coverag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ruta 42"/>
          <p:cNvSpPr/>
          <p:nvPr/>
        </p:nvSpPr>
        <p:spPr>
          <a:xfrm>
            <a:off x="1882080" y="2738520"/>
            <a:ext cx="48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og 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ruta 43"/>
          <p:cNvSpPr/>
          <p:nvPr/>
        </p:nvSpPr>
        <p:spPr>
          <a:xfrm>
            <a:off x="6148440" y="3833640"/>
            <a:ext cx="1707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hromosomal location, chr 1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ruta 44"/>
          <p:cNvSpPr/>
          <p:nvPr/>
        </p:nvSpPr>
        <p:spPr>
          <a:xfrm>
            <a:off x="1517760" y="3859200"/>
            <a:ext cx="1707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hromosomal location, chr 1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ktangel 45"/>
          <p:cNvSpPr/>
          <p:nvPr/>
        </p:nvSpPr>
        <p:spPr>
          <a:xfrm rot="16200000">
            <a:off x="-587880" y="1768680"/>
            <a:ext cx="1638360" cy="11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ruta 46"/>
          <p:cNvSpPr/>
          <p:nvPr/>
        </p:nvSpPr>
        <p:spPr>
          <a:xfrm rot="16200000">
            <a:off x="-341640" y="1543320"/>
            <a:ext cx="1070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llelic imbalance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5" descr=""/>
          <p:cNvPicPr/>
          <p:nvPr/>
        </p:nvPicPr>
        <p:blipFill>
          <a:blip r:embed="rId1"/>
          <a:stretch/>
        </p:blipFill>
        <p:spPr>
          <a:xfrm>
            <a:off x="4641840" y="735120"/>
            <a:ext cx="4429080" cy="327024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4" descr=""/>
          <p:cNvPicPr/>
          <p:nvPr/>
        </p:nvPicPr>
        <p:blipFill>
          <a:blip r:embed="rId2"/>
          <a:stretch/>
        </p:blipFill>
        <p:spPr>
          <a:xfrm>
            <a:off x="152280" y="743040"/>
            <a:ext cx="4416480" cy="3271680"/>
          </a:xfrm>
          <a:prstGeom prst="rect">
            <a:avLst/>
          </a:prstGeom>
          <a:ln w="0">
            <a:noFill/>
          </a:ln>
        </p:spPr>
      </p:pic>
      <p:sp>
        <p:nvSpPr>
          <p:cNvPr id="84" name="textruta 26"/>
          <p:cNvSpPr/>
          <p:nvPr/>
        </p:nvSpPr>
        <p:spPr>
          <a:xfrm>
            <a:off x="234360" y="3859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ruta 27"/>
          <p:cNvSpPr/>
          <p:nvPr/>
        </p:nvSpPr>
        <p:spPr>
          <a:xfrm>
            <a:off x="4586760" y="38592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ruta 31"/>
          <p:cNvSpPr/>
          <p:nvPr/>
        </p:nvSpPr>
        <p:spPr>
          <a:xfrm>
            <a:off x="482760" y="923760"/>
            <a:ext cx="48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A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ruta 32"/>
          <p:cNvSpPr/>
          <p:nvPr/>
        </p:nvSpPr>
        <p:spPr>
          <a:xfrm>
            <a:off x="4942800" y="914400"/>
            <a:ext cx="717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atchwork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ktangel 34"/>
          <p:cNvSpPr/>
          <p:nvPr/>
        </p:nvSpPr>
        <p:spPr>
          <a:xfrm>
            <a:off x="4584600" y="1146240"/>
            <a:ext cx="200160" cy="1290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ruta 33"/>
          <p:cNvSpPr/>
          <p:nvPr/>
        </p:nvSpPr>
        <p:spPr>
          <a:xfrm rot="16200000">
            <a:off x="4036680" y="1680120"/>
            <a:ext cx="1294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llelic imbalance ratio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ruta 35"/>
          <p:cNvSpPr/>
          <p:nvPr/>
        </p:nvSpPr>
        <p:spPr>
          <a:xfrm rot="16200000">
            <a:off x="4142520" y="3201120"/>
            <a:ext cx="97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otal and mino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py numbe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ruta 36"/>
          <p:cNvSpPr/>
          <p:nvPr/>
        </p:nvSpPr>
        <p:spPr>
          <a:xfrm rot="16200000">
            <a:off x="-335520" y="3172320"/>
            <a:ext cx="97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otal and mino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py numbe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ktangel 37"/>
          <p:cNvSpPr/>
          <p:nvPr/>
        </p:nvSpPr>
        <p:spPr>
          <a:xfrm>
            <a:off x="6429240" y="2757600"/>
            <a:ext cx="1143000" cy="11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ktangel 38"/>
          <p:cNvSpPr/>
          <p:nvPr/>
        </p:nvSpPr>
        <p:spPr>
          <a:xfrm>
            <a:off x="6143760" y="3849840"/>
            <a:ext cx="1638000" cy="117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ktangel 39"/>
          <p:cNvSpPr/>
          <p:nvPr/>
        </p:nvSpPr>
        <p:spPr>
          <a:xfrm>
            <a:off x="1447920" y="3881520"/>
            <a:ext cx="1638360" cy="11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ktangel 40"/>
          <p:cNvSpPr/>
          <p:nvPr/>
        </p:nvSpPr>
        <p:spPr>
          <a:xfrm>
            <a:off x="1447920" y="2776680"/>
            <a:ext cx="1638360" cy="11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ruta 41"/>
          <p:cNvSpPr/>
          <p:nvPr/>
        </p:nvSpPr>
        <p:spPr>
          <a:xfrm>
            <a:off x="6432840" y="2738520"/>
            <a:ext cx="1267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ormalized coverag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ruta 42"/>
          <p:cNvSpPr/>
          <p:nvPr/>
        </p:nvSpPr>
        <p:spPr>
          <a:xfrm>
            <a:off x="1882080" y="2738520"/>
            <a:ext cx="48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og 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ruta 43"/>
          <p:cNvSpPr/>
          <p:nvPr/>
        </p:nvSpPr>
        <p:spPr>
          <a:xfrm>
            <a:off x="6148080" y="3833640"/>
            <a:ext cx="1643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hromosomal location, chr 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ruta 44"/>
          <p:cNvSpPr/>
          <p:nvPr/>
        </p:nvSpPr>
        <p:spPr>
          <a:xfrm>
            <a:off x="1517040" y="3859200"/>
            <a:ext cx="1643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hromosomal location, chr 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ktangel 45"/>
          <p:cNvSpPr/>
          <p:nvPr/>
        </p:nvSpPr>
        <p:spPr>
          <a:xfrm rot="16200000">
            <a:off x="-587880" y="1768680"/>
            <a:ext cx="1638360" cy="115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ruta 46"/>
          <p:cNvSpPr/>
          <p:nvPr/>
        </p:nvSpPr>
        <p:spPr>
          <a:xfrm rot="16200000">
            <a:off x="-341640" y="1543320"/>
            <a:ext cx="1070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llelic imbalance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" name=""/>
          <p:cNvGraphicFramePr/>
          <p:nvPr/>
        </p:nvGraphicFramePr>
        <p:xfrm>
          <a:off x="800280" y="2133720"/>
          <a:ext cx="7742160" cy="2476440"/>
        </p:xfrm>
        <a:graphic>
          <a:graphicData uri="http://schemas.openxmlformats.org/drawingml/2006/table">
            <a:tbl>
              <a:tblPr/>
              <a:tblGrid>
                <a:gridCol w="1104840"/>
                <a:gridCol w="276120"/>
                <a:gridCol w="276120"/>
                <a:gridCol w="276480"/>
                <a:gridCol w="276120"/>
                <a:gridCol w="276120"/>
                <a:gridCol w="276120"/>
                <a:gridCol w="276480"/>
                <a:gridCol w="276120"/>
                <a:gridCol w="276120"/>
                <a:gridCol w="277920"/>
                <a:gridCol w="274680"/>
                <a:gridCol w="277920"/>
                <a:gridCol w="276120"/>
                <a:gridCol w="276120"/>
                <a:gridCol w="276120"/>
                <a:gridCol w="276480"/>
                <a:gridCol w="277560"/>
                <a:gridCol w="276480"/>
                <a:gridCol w="276120"/>
                <a:gridCol w="276120"/>
                <a:gridCol w="276480"/>
                <a:gridCol w="276120"/>
                <a:gridCol w="276120"/>
                <a:gridCol w="281160"/>
              </a:tblGrid>
              <a:tr h="742680"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[total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cop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number]m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[mino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copy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number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4"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Sensitivity (%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Specificity (%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True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Positiv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False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Negativ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True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Negativ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False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Positiv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7680"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Tumor fraction  (%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7680"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m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0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81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81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81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9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9.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7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7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7680"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5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3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3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5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6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3.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3.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3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3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7680"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4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5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0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1.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2.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3.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4.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6.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7.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7680"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4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5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8.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68.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4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9.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7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7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3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7680"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4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5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75.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87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4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7.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8.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8.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7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7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7680"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7.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64.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67.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58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87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6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5.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7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2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44928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sv-SE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Arial Unicode MS"/>
                        </a:rPr>
                        <a:t>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320" marR="43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03" name="Rectangle 155"/>
          <p:cNvSpPr/>
          <p:nvPr/>
        </p:nvSpPr>
        <p:spPr>
          <a:xfrm>
            <a:off x="723960" y="678600"/>
            <a:ext cx="80773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072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Supplementa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Tabl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 Segment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used for sensitivity and specificity estimates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in evaluating Patchwork performance i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cell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lin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HCC195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with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TAP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analysi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as gol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standard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Allele-specific copy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number composition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with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TP+F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&gt;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15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segment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wer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included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Segment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wer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require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to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b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a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leas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i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siz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an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hav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a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overla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o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75%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or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 Unicode MS"/>
              </a:rPr>
              <a:t>more with the microarray dat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072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0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5T13:44:03Z</dcterms:created>
  <dc:creator>Markus Rasmussen</dc:creator>
  <dc:description/>
  <dc:language>en-US</dc:language>
  <cp:lastModifiedBy>Markus Mayrhofer</cp:lastModifiedBy>
  <dcterms:modified xsi:type="dcterms:W3CDTF">2013-02-26T13:50:33Z</dcterms:modified>
  <cp:revision>14</cp:revision>
  <dc:subject/>
  <dc:title>PowerPoint-presentation</dc:title>
</cp:coreProperties>
</file>